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>
      <p:cViewPr varScale="1">
        <p:scale>
          <a:sx n="50" d="100"/>
          <a:sy n="50" d="100"/>
        </p:scale>
        <p:origin x="27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杉山 洋平" userId="d0fe6308d8163d7d" providerId="LiveId" clId="{0870BED2-AC28-4213-9BA3-912D3D634627}"/>
    <pc:docChg chg="custSel delSld modSld sldOrd">
      <pc:chgData name="杉山 洋平" userId="d0fe6308d8163d7d" providerId="LiveId" clId="{0870BED2-AC28-4213-9BA3-912D3D634627}" dt="2021-12-24T14:10:01.703" v="59" actId="47"/>
      <pc:docMkLst>
        <pc:docMk/>
      </pc:docMkLst>
      <pc:sldChg chg="ord">
        <pc:chgData name="杉山 洋平" userId="d0fe6308d8163d7d" providerId="LiveId" clId="{0870BED2-AC28-4213-9BA3-912D3D634627}" dt="2021-12-23T22:56:38.457" v="28"/>
        <pc:sldMkLst>
          <pc:docMk/>
          <pc:sldMk cId="1119843062" sldId="262"/>
        </pc:sldMkLst>
      </pc:sldChg>
      <pc:sldChg chg="del">
        <pc:chgData name="杉山 洋平" userId="d0fe6308d8163d7d" providerId="LiveId" clId="{0870BED2-AC28-4213-9BA3-912D3D634627}" dt="2021-12-24T14:10:01.703" v="59" actId="47"/>
        <pc:sldMkLst>
          <pc:docMk/>
          <pc:sldMk cId="3665213163" sldId="264"/>
        </pc:sldMkLst>
      </pc:sldChg>
      <pc:sldChg chg="del">
        <pc:chgData name="杉山 洋平" userId="d0fe6308d8163d7d" providerId="LiveId" clId="{0870BED2-AC28-4213-9BA3-912D3D634627}" dt="2021-12-24T14:10:01.392" v="58" actId="47"/>
        <pc:sldMkLst>
          <pc:docMk/>
          <pc:sldMk cId="1943628669" sldId="265"/>
        </pc:sldMkLst>
      </pc:sldChg>
      <pc:sldChg chg="del">
        <pc:chgData name="杉山 洋平" userId="d0fe6308d8163d7d" providerId="LiveId" clId="{0870BED2-AC28-4213-9BA3-912D3D634627}" dt="2021-12-24T14:10:01.021" v="57" actId="47"/>
        <pc:sldMkLst>
          <pc:docMk/>
          <pc:sldMk cId="3812443" sldId="266"/>
        </pc:sldMkLst>
      </pc:sldChg>
      <pc:sldChg chg="modSp mod">
        <pc:chgData name="杉山 洋平" userId="d0fe6308d8163d7d" providerId="LiveId" clId="{0870BED2-AC28-4213-9BA3-912D3D634627}" dt="2021-12-24T14:09:49.388" v="56" actId="6549"/>
        <pc:sldMkLst>
          <pc:docMk/>
          <pc:sldMk cId="291564166" sldId="267"/>
        </pc:sldMkLst>
        <pc:spChg chg="mod">
          <ac:chgData name="杉山 洋平" userId="d0fe6308d8163d7d" providerId="LiveId" clId="{0870BED2-AC28-4213-9BA3-912D3D634627}" dt="2021-12-24T14:09:49.388" v="56" actId="6549"/>
          <ac:spMkLst>
            <pc:docMk/>
            <pc:sldMk cId="291564166" sldId="267"/>
            <ac:spMk id="2" creationId="{5179D515-31E7-47F5-A3A7-8AC3E346B068}"/>
          </ac:spMkLst>
        </pc:spChg>
        <pc:spChg chg="mod">
          <ac:chgData name="杉山 洋平" userId="d0fe6308d8163d7d" providerId="LiveId" clId="{0870BED2-AC28-4213-9BA3-912D3D634627}" dt="2021-12-24T14:09:28.319" v="30" actId="27636"/>
          <ac:spMkLst>
            <pc:docMk/>
            <pc:sldMk cId="291564166" sldId="267"/>
            <ac:spMk id="3" creationId="{622E4190-D5FE-485A-9FFA-9469F8CE101E}"/>
          </ac:spMkLst>
        </pc:spChg>
      </pc:sldChg>
    </pc:docChg>
  </pc:docChgLst>
  <pc:docChgLst>
    <pc:chgData name="杉山 洋平" userId="d0fe6308d8163d7d" providerId="LiveId" clId="{9123ABAD-CF0A-4573-9BE3-45A73A43731D}"/>
    <pc:docChg chg="modSld">
      <pc:chgData name="杉山 洋平" userId="d0fe6308d8163d7d" providerId="LiveId" clId="{9123ABAD-CF0A-4573-9BE3-45A73A43731D}" dt="2021-12-27T06:12:17.062" v="0" actId="207"/>
      <pc:docMkLst>
        <pc:docMk/>
      </pc:docMkLst>
      <pc:sldChg chg="modSp mod">
        <pc:chgData name="杉山 洋平" userId="d0fe6308d8163d7d" providerId="LiveId" clId="{9123ABAD-CF0A-4573-9BE3-45A73A43731D}" dt="2021-12-27T06:12:17.062" v="0" actId="207"/>
        <pc:sldMkLst>
          <pc:docMk/>
          <pc:sldMk cId="291564166" sldId="267"/>
        </pc:sldMkLst>
        <pc:spChg chg="mod">
          <ac:chgData name="杉山 洋平" userId="d0fe6308d8163d7d" providerId="LiveId" clId="{9123ABAD-CF0A-4573-9BE3-45A73A43731D}" dt="2021-12-27T06:12:17.062" v="0" actId="207"/>
          <ac:spMkLst>
            <pc:docMk/>
            <pc:sldMk cId="291564166" sldId="267"/>
            <ac:spMk id="2" creationId="{5179D515-31E7-47F5-A3A7-8AC3E346B06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7E3D98-A1CD-4C13-85A4-DF820D3997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30586A9-2438-4C9F-83C5-06C8590C18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191043-9506-4753-BF13-306DB9EE5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33093E-20BC-4252-88A3-D7CE40F4A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E03780F-6922-4861-81CD-73EFCBE60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772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FF1DC9-4300-4C93-B781-AC77442ED2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C01A00B-48A3-4C41-92C3-C42141F172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5CA3A5-54D0-44B6-ACC5-07AA0305A1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8514A0-D38D-40D3-9B28-135B13F66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A8DF635-94AD-47AB-AC5B-517A75705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314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A0FC3E2-502E-475E-93C1-20D770483D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0E43C16-D975-4D55-9804-613AFA1C7A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B33B37-FDB9-4BB6-BEF7-A65DB3EF7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968965-B46E-4523-95E2-38FF573D7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3DA8F2-6436-4BAA-9746-72C077AAE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3141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75F361-AB5F-4360-B27E-A2F26C7078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5D26598-6C8B-4F03-B739-701B431B0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2816DF-601D-4F59-8FEE-F834989125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DB6CFC-D673-4A25-8AA7-14DFC1D8D0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1392C4-503C-4BAB-A64F-49B9386598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0842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787DA9-E852-4DBE-9496-8BE5B7B7A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67A8E0A-47B1-4429-A163-E283FC34F9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2B2993-A9B2-45D0-911D-A271C6CFF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9756D6-FDA7-4A07-AEBA-30D05B885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1BA6DB-AB9D-4130-B1DF-BEDBD2EE6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5810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26C297-CD83-476D-AC0F-3E507F3CD0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D90AC2-86BF-4106-9A09-B4B86556DF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C30C400-2ECB-4CCC-860B-973E2C6C2A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66B0F7B-1630-40C3-93D4-9DD67BBB4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177D0D5-BB86-4C4F-B660-9E269125E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6519AC9-40A4-4347-A8FC-67209A19E7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6967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EF3A42-19F2-4CD5-9CBE-616BE010C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A13F1B0-B2F3-4187-A726-7338256319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A456A82-36F7-411C-9E9D-092B89FDB2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2CA7348-9337-4C3E-8283-471245902B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3260DFE-4991-4A32-AB53-E1AAB3FDA3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B91D6B6-A4C5-45BC-A956-D767F5FC0A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1E8F62A-34F2-416E-AEF9-DF361EF624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65DFA17-AB69-4696-8483-3AB133603D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7355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DF5AFF-E012-4907-B6AC-0B8510DF5B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8B8D6D8-38DC-4D6C-B160-83B6986C6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3AEC779-8DF2-467A-B0B8-B830232AE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02FFDAC-6550-41E6-9AD6-CE0ED6822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158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52DB93A-3E5D-44E0-8531-8529846680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7927A88-C8DA-4658-8A8B-B37159AEA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3DBF72C-1863-41D6-AC13-5FD45460F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0187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6AAD7D-4438-406E-8163-F44FCFA06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290BEA7-96CD-4D3A-897B-EC4887CC58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AC24186-3EA9-47FE-8C44-D4E5DE7BBE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A210801-4A63-415B-9569-2FA919196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D7D88A-C6B7-405C-9012-30E41F510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F3218F-262E-4BD4-BF63-A1FF557159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065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4802FB-BAB8-4647-9C59-2DCA2DBA04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A268CA4-29F8-4F96-BEE0-D476F03D06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86D525B-6AC6-4BF5-8FF0-A6F7D6A529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F23A494-EA62-491E-A53D-E9B3B1096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DE7FD9C-E4CF-453E-A39E-6054B1A9D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BDD704B-A838-42F4-AB37-F4923D80E8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719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8F39ABC-BFB9-472B-BB93-A1C1413DB8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ECB2E6-749D-4861-952F-B7A428104D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C7EE1B-04E7-4F7D-A418-EC561E63CC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C9FD7C-F15E-4C08-A726-FF84069BFECD}" type="datetimeFigureOut">
              <a:rPr kumimoji="1" lang="ja-JP" altLang="en-US" smtClean="0"/>
              <a:t>2021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4678C6-E8E2-4D7A-9E88-9AE8C9E6E4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F88C47-3566-46F8-9E1D-2E0B338108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40FF2C-48E9-48ED-823F-D7183FADD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815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79D515-31E7-47F5-A3A7-8AC3E346B0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Additional file 2</a:t>
            </a:r>
            <a:br>
              <a:rPr lang="en-US" altLang="ja-JP" dirty="0"/>
            </a:br>
            <a:r>
              <a:rPr kumimoji="1" lang="en-US" altLang="ja-JP" dirty="0"/>
              <a:t>Skin changes noted in each case</a:t>
            </a:r>
            <a:endParaRPr kumimoji="1" lang="ja-JP" altLang="en-US" dirty="0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22E4190-D5FE-485A-9FFA-9469F8CE10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kumimoji="1" lang="en-US" altLang="ja-JP" dirty="0"/>
              <a:t>Case 1: Right arm have mild lipoatrophy  </a:t>
            </a:r>
          </a:p>
          <a:p>
            <a:r>
              <a:rPr kumimoji="1" lang="en-US" altLang="ja-JP" dirty="0"/>
              <a:t>Case 2: Left leg have  mild lipoatrophy with mild redness</a:t>
            </a:r>
          </a:p>
          <a:p>
            <a:r>
              <a:rPr kumimoji="1" lang="en-US" altLang="ja-JP" dirty="0"/>
              <a:t>Case 4: Left arm have mild lipoatrophy with mild redness   </a:t>
            </a:r>
          </a:p>
          <a:p>
            <a:r>
              <a:rPr kumimoji="1" lang="en-US" altLang="ja-JP" dirty="0"/>
              <a:t>Case 5: Right arm have </a:t>
            </a:r>
            <a:r>
              <a:rPr kumimoji="1" lang="en-US" altLang="ja-JP" dirty="0" err="1"/>
              <a:t>lipohypertrophy</a:t>
            </a:r>
            <a:r>
              <a:rPr kumimoji="1" lang="en-US" altLang="ja-JP" dirty="0"/>
              <a:t> with redness</a:t>
            </a:r>
          </a:p>
          <a:p>
            <a:pPr marL="0" indent="0">
              <a:buNone/>
            </a:pPr>
            <a:r>
              <a:rPr lang="en-US" altLang="ja-JP" dirty="0"/>
              <a:t>         </a:t>
            </a:r>
            <a:r>
              <a:rPr kumimoji="1" lang="en-US" altLang="ja-JP" dirty="0"/>
              <a:t>       Left abdomen have lipoatrophy </a:t>
            </a:r>
          </a:p>
          <a:p>
            <a:r>
              <a:rPr kumimoji="1" lang="en-US" altLang="ja-JP" dirty="0"/>
              <a:t>Case 8: Right arm have </a:t>
            </a:r>
            <a:r>
              <a:rPr kumimoji="1" lang="en-US" altLang="ja-JP" dirty="0" err="1"/>
              <a:t>lipohypertrophy</a:t>
            </a:r>
            <a:r>
              <a:rPr kumimoji="1" lang="en-US" altLang="ja-JP" dirty="0"/>
              <a:t> with redness</a:t>
            </a:r>
          </a:p>
          <a:p>
            <a:pPr marL="0" indent="0">
              <a:buNone/>
            </a:pPr>
            <a:r>
              <a:rPr lang="en-US" altLang="ja-JP" dirty="0"/>
              <a:t>        </a:t>
            </a:r>
            <a:r>
              <a:rPr kumimoji="1" lang="en-US" altLang="ja-JP" dirty="0"/>
              <a:t>        Both side of abdomen have lipoatrophy </a:t>
            </a:r>
          </a:p>
          <a:p>
            <a:r>
              <a:rPr kumimoji="1" lang="en-US" altLang="ja-JP" dirty="0"/>
              <a:t>Case 9: Left arm have </a:t>
            </a:r>
            <a:r>
              <a:rPr kumimoji="1" lang="en-US" altLang="ja-JP" dirty="0" err="1"/>
              <a:t>lipohypertrophy</a:t>
            </a:r>
            <a:r>
              <a:rPr kumimoji="1" lang="en-US" altLang="ja-JP" dirty="0"/>
              <a:t> with redness</a:t>
            </a:r>
          </a:p>
          <a:p>
            <a:pPr marL="0" indent="0">
              <a:buNone/>
            </a:pPr>
            <a:r>
              <a:rPr kumimoji="1" lang="en-US" altLang="ja-JP" dirty="0"/>
              <a:t>                Left leg have </a:t>
            </a:r>
            <a:r>
              <a:rPr kumimoji="1" lang="en-US" altLang="ja-JP" dirty="0" err="1"/>
              <a:t>lipohypertrophy</a:t>
            </a:r>
            <a:r>
              <a:rPr kumimoji="1" lang="en-US" altLang="ja-JP" dirty="0"/>
              <a:t> with redness </a:t>
            </a:r>
          </a:p>
          <a:p>
            <a:r>
              <a:rPr kumimoji="1" lang="en-US" altLang="ja-JP" dirty="0"/>
              <a:t>Case 10: Right leg have mild </a:t>
            </a:r>
            <a:r>
              <a:rPr kumimoji="1" lang="en-US" altLang="ja-JP" dirty="0" err="1"/>
              <a:t>lipohypertrophy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15641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FEDE19-9D54-43D0-A714-EDF7339934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ase 1</a:t>
            </a:r>
            <a:endParaRPr kumimoji="1" lang="ja-JP" altLang="en-US" dirty="0"/>
          </a:p>
        </p:txBody>
      </p:sp>
      <p:pic>
        <p:nvPicPr>
          <p:cNvPr id="5" name="コンテンツ プレースホルダー 4" descr="人, 屋内, 女性, 持つ が含まれている画像&#10;&#10;自動的に生成された説明">
            <a:extLst>
              <a:ext uri="{FF2B5EF4-FFF2-40B4-BE49-F238E27FC236}">
                <a16:creationId xmlns:a16="http://schemas.microsoft.com/office/drawing/2014/main" id="{A6FB7F35-F811-4496-96CE-702C7C36988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879" y="108294"/>
            <a:ext cx="4977833" cy="6635613"/>
          </a:xfrm>
        </p:spPr>
      </p:pic>
    </p:spTree>
    <p:extLst>
      <p:ext uri="{BB962C8B-B14F-4D97-AF65-F5344CB8AC3E}">
        <p14:creationId xmlns:p14="http://schemas.microsoft.com/office/powerpoint/2010/main" val="29402875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A71F1B-DB55-495D-8C29-C4303B7C5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/>
              <a:t>Case 2</a:t>
            </a:r>
            <a:endParaRPr kumimoji="1" lang="ja-JP" altLang="en-US" dirty="0"/>
          </a:p>
        </p:txBody>
      </p:sp>
      <p:pic>
        <p:nvPicPr>
          <p:cNvPr id="5" name="コンテンツ プレースホルダー 4" descr="下着を履いた足&#10;&#10;中程度の精度で自動的に生成された説明">
            <a:extLst>
              <a:ext uri="{FF2B5EF4-FFF2-40B4-BE49-F238E27FC236}">
                <a16:creationId xmlns:a16="http://schemas.microsoft.com/office/drawing/2014/main" id="{15B53B19-431A-4897-A2C1-72525DA0161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9655" y="1825625"/>
            <a:ext cx="7732690" cy="4351338"/>
          </a:xfrm>
        </p:spPr>
      </p:pic>
    </p:spTree>
    <p:extLst>
      <p:ext uri="{BB962C8B-B14F-4D97-AF65-F5344CB8AC3E}">
        <p14:creationId xmlns:p14="http://schemas.microsoft.com/office/powerpoint/2010/main" val="25321387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419DF7-D72D-4D90-9AE1-251EBC2908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/>
              <a:t>Case 4 </a:t>
            </a:r>
            <a:endParaRPr kumimoji="1" lang="ja-JP" altLang="en-US" dirty="0"/>
          </a:p>
        </p:txBody>
      </p:sp>
      <p:pic>
        <p:nvPicPr>
          <p:cNvPr id="5" name="コンテンツ プレースホルダー 4" descr="人の足&#10;&#10;自動的に生成された説明">
            <a:extLst>
              <a:ext uri="{FF2B5EF4-FFF2-40B4-BE49-F238E27FC236}">
                <a16:creationId xmlns:a16="http://schemas.microsoft.com/office/drawing/2014/main" id="{00A4CAF6-16CD-4D56-9B1B-08B74D4C49D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634955" y="953051"/>
            <a:ext cx="6629571" cy="4972177"/>
          </a:xfrm>
        </p:spPr>
      </p:pic>
    </p:spTree>
    <p:extLst>
      <p:ext uri="{BB962C8B-B14F-4D97-AF65-F5344CB8AC3E}">
        <p14:creationId xmlns:p14="http://schemas.microsoft.com/office/powerpoint/2010/main" val="41357301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4AD337-AA8E-4DED-8EEE-15D6B95B87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/>
              <a:t>Case 5</a:t>
            </a:r>
            <a:endParaRPr kumimoji="1" lang="ja-JP" altLang="en-US" dirty="0"/>
          </a:p>
        </p:txBody>
      </p:sp>
      <p:pic>
        <p:nvPicPr>
          <p:cNvPr id="5" name="コンテンツ プレースホルダー 4" descr="手で顔を隠している人の足&#10;&#10;低い精度で自動的に生成された説明">
            <a:extLst>
              <a:ext uri="{FF2B5EF4-FFF2-40B4-BE49-F238E27FC236}">
                <a16:creationId xmlns:a16="http://schemas.microsoft.com/office/drawing/2014/main" id="{C2913909-426D-42F5-B1C6-99AF676C154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1237" y="449500"/>
            <a:ext cx="3409525" cy="6059010"/>
          </a:xfrm>
        </p:spPr>
      </p:pic>
      <p:pic>
        <p:nvPicPr>
          <p:cNvPr id="7" name="図 6" descr="下着を着ている&#10;&#10;自動的に生成された説明">
            <a:extLst>
              <a:ext uri="{FF2B5EF4-FFF2-40B4-BE49-F238E27FC236}">
                <a16:creationId xmlns:a16="http://schemas.microsoft.com/office/drawing/2014/main" id="{B87005DA-AC57-485B-A381-1D3ABF8528A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1234" y="390524"/>
            <a:ext cx="3475899" cy="61769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91143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6E8354-B964-4EAC-8CF3-B9848EF77B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/>
              <a:t>Case 8</a:t>
            </a:r>
            <a:endParaRPr kumimoji="1" lang="ja-JP" altLang="en-US" dirty="0"/>
          </a:p>
        </p:txBody>
      </p:sp>
      <p:pic>
        <p:nvPicPr>
          <p:cNvPr id="5" name="コンテンツ プレースホルダー 4" descr="下着を履いた足&#10;&#10;中程度の精度で自動的に生成された説明">
            <a:extLst>
              <a:ext uri="{FF2B5EF4-FFF2-40B4-BE49-F238E27FC236}">
                <a16:creationId xmlns:a16="http://schemas.microsoft.com/office/drawing/2014/main" id="{B49694A1-600D-4AC5-A8D6-313FBF797A3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975" y="2141537"/>
            <a:ext cx="7728841" cy="4351338"/>
          </a:xfrm>
        </p:spPr>
      </p:pic>
      <p:pic>
        <p:nvPicPr>
          <p:cNvPr id="7" name="図 6" descr="屋内, 座る, テーブル, 茶色 が含まれている画像&#10;&#10;自動的に生成された説明">
            <a:extLst>
              <a:ext uri="{FF2B5EF4-FFF2-40B4-BE49-F238E27FC236}">
                <a16:creationId xmlns:a16="http://schemas.microsoft.com/office/drawing/2014/main" id="{A657CA65-07F7-493F-AC60-18B3AF797CB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871939" y="1665578"/>
            <a:ext cx="6176963" cy="34776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18298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EB8431-D498-40A1-8F1F-6B436CBA9B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/>
              <a:t>Case 9</a:t>
            </a:r>
            <a:endParaRPr kumimoji="1" lang="ja-JP" altLang="en-US" dirty="0"/>
          </a:p>
        </p:txBody>
      </p:sp>
      <p:pic>
        <p:nvPicPr>
          <p:cNvPr id="5" name="コンテンツ プレースホルダー 4" descr="人の足&#10;&#10;自動的に生成された説明">
            <a:extLst>
              <a:ext uri="{FF2B5EF4-FFF2-40B4-BE49-F238E27FC236}">
                <a16:creationId xmlns:a16="http://schemas.microsoft.com/office/drawing/2014/main" id="{47CE6C64-AFC1-41D5-9B86-116F987D4D0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5433" y="60161"/>
            <a:ext cx="3274827" cy="6549654"/>
          </a:xfrm>
        </p:spPr>
      </p:pic>
      <p:pic>
        <p:nvPicPr>
          <p:cNvPr id="9" name="図 8" descr="手で顔を隠している人の足&#10;&#10;低い精度で自動的に生成された説明">
            <a:extLst>
              <a:ext uri="{FF2B5EF4-FFF2-40B4-BE49-F238E27FC236}">
                <a16:creationId xmlns:a16="http://schemas.microsoft.com/office/drawing/2014/main" id="{B1CA2EB6-99BA-48C1-BC64-52908651E0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23111" y="60161"/>
            <a:ext cx="3274827" cy="65496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98430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50A11A-2FB1-4725-B22D-A23ACE3242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/>
              <a:t>Case 10</a:t>
            </a:r>
            <a:endParaRPr kumimoji="1" lang="ja-JP" altLang="en-US" dirty="0"/>
          </a:p>
        </p:txBody>
      </p:sp>
      <p:pic>
        <p:nvPicPr>
          <p:cNvPr id="7" name="図 6" descr="人の足&#10;&#10;自動的に生成された説明">
            <a:extLst>
              <a:ext uri="{FF2B5EF4-FFF2-40B4-BE49-F238E27FC236}">
                <a16:creationId xmlns:a16="http://schemas.microsoft.com/office/drawing/2014/main" id="{9071E928-6C72-45EB-9721-AA504ACC02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0700" y="148856"/>
            <a:ext cx="4960531" cy="66140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22823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5</TotalTime>
  <Words>108</Words>
  <Application>Microsoft Office PowerPoint</Application>
  <PresentationFormat>ワイド画面</PresentationFormat>
  <Paragraphs>18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2" baseType="lpstr">
      <vt:lpstr>游ゴシック</vt:lpstr>
      <vt:lpstr>游ゴシック Light</vt:lpstr>
      <vt:lpstr>Arial</vt:lpstr>
      <vt:lpstr>Office テーマ</vt:lpstr>
      <vt:lpstr>Additional file 2 Skin changes noted in each case</vt:lpstr>
      <vt:lpstr>Case 1</vt:lpstr>
      <vt:lpstr>Case 2</vt:lpstr>
      <vt:lpstr>Case 4 </vt:lpstr>
      <vt:lpstr>Case 5</vt:lpstr>
      <vt:lpstr>Case 8</vt:lpstr>
      <vt:lpstr>Case 9</vt:lpstr>
      <vt:lpstr>Case 10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</dc:title>
  <dc:creator>杉山 洋平</dc:creator>
  <cp:lastModifiedBy>杉山 洋平</cp:lastModifiedBy>
  <cp:revision>4</cp:revision>
  <dcterms:created xsi:type="dcterms:W3CDTF">2021-12-23T19:06:07Z</dcterms:created>
  <dcterms:modified xsi:type="dcterms:W3CDTF">2021-12-27T06:12:19Z</dcterms:modified>
</cp:coreProperties>
</file>